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7619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8485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9606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2818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4037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65163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08978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7280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2299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3182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1459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BCE4A-FB0F-4307-A0FE-B0C77B3876FB}" type="datetimeFigureOut">
              <a:rPr lang="ko-KR" altLang="en-US" smtClean="0"/>
              <a:t>2024-09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1EA88-914E-418A-9EFC-729D14B5896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5243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microsoft.com/office/2007/relationships/hdphoto" Target="../media/hdphoto2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7" Type="http://schemas.openxmlformats.org/officeDocument/2006/relationships/image" Target="../media/image10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1265147" y="1242235"/>
            <a:ext cx="3336925" cy="2595563"/>
            <a:chOff x="4029319" y="275771"/>
            <a:chExt cx="3598930" cy="2830473"/>
          </a:xfrm>
        </p:grpSpPr>
        <p:sp>
          <p:nvSpPr>
            <p:cNvPr id="5" name="TextBox 4"/>
            <p:cNvSpPr txBox="1"/>
            <p:nvPr/>
          </p:nvSpPr>
          <p:spPr>
            <a:xfrm>
              <a:off x="5333529" y="611545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429940" y="1844646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5770281" y="2202322"/>
              <a:ext cx="1683521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8" name="개체 7"/>
            <p:cNvGraphicFramePr>
              <a:graphicFrameLocks noChangeAspect="1"/>
            </p:cNvGraphicFramePr>
            <p:nvPr/>
          </p:nvGraphicFramePr>
          <p:xfrm>
            <a:off x="4029319" y="275771"/>
            <a:ext cx="3598930" cy="28304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" imgW="3598200" imgH="2829960" progId="Prism5.Document">
                    <p:embed/>
                  </p:oleObj>
                </mc:Choice>
                <mc:Fallback>
                  <p:oleObj name="Prism 5" r:id="rId2" imgW="3598200" imgH="2829960" progId="Prism5.Document">
                    <p:embed/>
                    <p:pic>
                      <p:nvPicPr>
                        <p:cNvPr id="16" name="개체 15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4029319" y="275771"/>
                          <a:ext cx="3598930" cy="283047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9" name="그룹 8"/>
          <p:cNvGrpSpPr/>
          <p:nvPr/>
        </p:nvGrpSpPr>
        <p:grpSpPr>
          <a:xfrm>
            <a:off x="4602072" y="1242236"/>
            <a:ext cx="3344862" cy="2595562"/>
            <a:chOff x="7685076" y="764377"/>
            <a:chExt cx="3553097" cy="2830472"/>
          </a:xfrm>
        </p:grpSpPr>
        <p:cxnSp>
          <p:nvCxnSpPr>
            <p:cNvPr id="10" name="직선 연결선 9"/>
            <p:cNvCxnSpPr/>
            <p:nvPr/>
          </p:nvCxnSpPr>
          <p:spPr>
            <a:xfrm>
              <a:off x="9433779" y="2643844"/>
              <a:ext cx="151212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" name="그룹 10"/>
            <p:cNvGrpSpPr/>
            <p:nvPr/>
          </p:nvGrpSpPr>
          <p:grpSpPr>
            <a:xfrm>
              <a:off x="7685076" y="764377"/>
              <a:ext cx="3553097" cy="2830472"/>
              <a:chOff x="7685076" y="764377"/>
              <a:chExt cx="3553097" cy="2830472"/>
            </a:xfrm>
          </p:grpSpPr>
          <p:graphicFrame>
            <p:nvGraphicFramePr>
              <p:cNvPr id="12" name="개체 11"/>
              <p:cNvGraphicFramePr>
                <a:graphicFrameLocks noChangeAspect="1"/>
              </p:cNvGraphicFramePr>
              <p:nvPr/>
            </p:nvGraphicFramePr>
            <p:xfrm>
              <a:off x="7685076" y="764377"/>
              <a:ext cx="3553097" cy="283047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5" r:id="rId4" imgW="3552480" imgH="2829960" progId="Prism5.Document">
                      <p:embed/>
                    </p:oleObj>
                  </mc:Choice>
                  <mc:Fallback>
                    <p:oleObj name="Prism 5" r:id="rId4" imgW="3552480" imgH="2829960" progId="Prism5.Document">
                      <p:embed/>
                      <p:pic>
                        <p:nvPicPr>
                          <p:cNvPr id="20" name="개체 19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7685076" y="764377"/>
                            <a:ext cx="3553097" cy="283047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3" name="TextBox 12"/>
              <p:cNvSpPr txBox="1"/>
              <p:nvPr/>
            </p:nvSpPr>
            <p:spPr>
              <a:xfrm>
                <a:off x="8947427" y="946021"/>
                <a:ext cx="28245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ko-KR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9980846" y="2306047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" name="TextBox 14"/>
          <p:cNvSpPr txBox="1"/>
          <p:nvPr/>
        </p:nvSpPr>
        <p:spPr>
          <a:xfrm>
            <a:off x="1265147" y="77896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50152" y="77896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02835" y="5251520"/>
            <a:ext cx="113701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Supplementary Figure S1</a:t>
            </a:r>
            <a:r>
              <a:rPr lang="en-US" altLang="ko-KR" dirty="0"/>
              <a:t>. Inflammatory cytokines produced </a:t>
            </a:r>
            <a:r>
              <a:rPr lang="en-US" altLang="ko-KR" dirty="0">
                <a:ea typeface="맑은 고딕" panose="020B0503020000020004" pitchFamily="50" charset="-127"/>
              </a:rPr>
              <a:t>by RAW264.7 cells treated with </a:t>
            </a:r>
            <a:r>
              <a:rPr lang="el-GR" altLang="ko-KR" dirty="0">
                <a:ea typeface="맑은 고딕" panose="020B0503020000020004" pitchFamily="50" charset="-127"/>
              </a:rPr>
              <a:t>β</a:t>
            </a:r>
            <a:r>
              <a:rPr lang="en-US" altLang="ko-KR">
                <a:ea typeface="맑은 고딕" panose="020B0503020000020004" pitchFamily="50" charset="-127"/>
              </a:rPr>
              <a:t>-1,3-glucan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980562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892995" y="1032976"/>
            <a:ext cx="3486840" cy="1709829"/>
            <a:chOff x="7865320" y="557847"/>
            <a:chExt cx="3486840" cy="1709829"/>
          </a:xfrm>
        </p:grpSpPr>
        <p:grpSp>
          <p:nvGrpSpPr>
            <p:cNvPr id="5" name="그룹 4"/>
            <p:cNvGrpSpPr/>
            <p:nvPr/>
          </p:nvGrpSpPr>
          <p:grpSpPr>
            <a:xfrm>
              <a:off x="7865320" y="557847"/>
              <a:ext cx="3384631" cy="1709829"/>
              <a:chOff x="7483069" y="753658"/>
              <a:chExt cx="3384631" cy="1709829"/>
            </a:xfrm>
          </p:grpSpPr>
          <p:pic>
            <p:nvPicPr>
              <p:cNvPr id="13" name="그림 1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15933" t="49393" r="8062" b="17764"/>
              <a:stretch/>
            </p:blipFill>
            <p:spPr>
              <a:xfrm>
                <a:off x="8279507" y="1709771"/>
                <a:ext cx="1951856" cy="350509"/>
              </a:xfrm>
              <a:prstGeom prst="rect">
                <a:avLst/>
              </a:prstGeom>
              <a:ln w="22225">
                <a:solidFill>
                  <a:schemeClr val="tx1"/>
                </a:solidFill>
              </a:ln>
            </p:spPr>
          </p:pic>
          <p:pic>
            <p:nvPicPr>
              <p:cNvPr id="14" name="그림 13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rcRect l="17894" t="29676" r="12947" b="27917"/>
              <a:stretch/>
            </p:blipFill>
            <p:spPr>
              <a:xfrm>
                <a:off x="8267050" y="2112978"/>
                <a:ext cx="1964312" cy="350509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5" name="그림 14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17026" t="25125" r="9785" b="64640"/>
              <a:stretch/>
            </p:blipFill>
            <p:spPr>
              <a:xfrm>
                <a:off x="8279507" y="1306564"/>
                <a:ext cx="1959980" cy="350509"/>
              </a:xfrm>
              <a:prstGeom prst="rect">
                <a:avLst/>
              </a:prstGeom>
              <a:ln w="15875">
                <a:solidFill>
                  <a:schemeClr val="tx1"/>
                </a:solidFill>
              </a:ln>
            </p:spPr>
          </p:pic>
          <p:pic>
            <p:nvPicPr>
              <p:cNvPr id="16" name="그림 15"/>
              <p:cNvPicPr>
                <a:picLocks noChangeAspect="1"/>
              </p:cNvPicPr>
              <p:nvPr/>
            </p:nvPicPr>
            <p:blipFill rotWithShape="1">
              <a:blip r:embed="rId8"/>
              <a:srcRect b="60324"/>
              <a:stretch/>
            </p:blipFill>
            <p:spPr>
              <a:xfrm>
                <a:off x="7483069" y="753658"/>
                <a:ext cx="3384631" cy="525170"/>
              </a:xfrm>
              <a:prstGeom prst="rect">
                <a:avLst/>
              </a:prstGeom>
            </p:spPr>
          </p:pic>
        </p:grpSp>
        <p:sp>
          <p:nvSpPr>
            <p:cNvPr id="6" name="TextBox 5"/>
            <p:cNvSpPr txBox="1"/>
            <p:nvPr/>
          </p:nvSpPr>
          <p:spPr>
            <a:xfrm>
              <a:off x="8011753" y="1120180"/>
              <a:ext cx="6319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LR2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011753" y="1555076"/>
              <a:ext cx="63190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LR4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7873894" y="1950472"/>
              <a:ext cx="7697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14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β</a:t>
              </a:r>
              <a:r>
                <a:rPr lang="en-US" altLang="ko-KR" sz="14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actin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직선 연결선 8"/>
            <p:cNvCxnSpPr/>
            <p:nvPr/>
          </p:nvCxnSpPr>
          <p:spPr>
            <a:xfrm>
              <a:off x="10669842" y="1274068"/>
              <a:ext cx="12254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" name="직선 연결선 9"/>
            <p:cNvCxnSpPr/>
            <p:nvPr/>
          </p:nvCxnSpPr>
          <p:spPr>
            <a:xfrm>
              <a:off x="10669842" y="1728128"/>
              <a:ext cx="122549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10740543" y="1141530"/>
              <a:ext cx="5597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97kD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0792391" y="1605017"/>
              <a:ext cx="5597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95kDa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482129" y="4607706"/>
            <a:ext cx="11154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Supplementary Figure S2</a:t>
            </a:r>
            <a:r>
              <a:rPr lang="en-US" altLang="ko-KR" dirty="0"/>
              <a:t>. Expression of TLR2 and TLR4 in </a:t>
            </a:r>
            <a:r>
              <a:rPr lang="en-US" altLang="ko-KR" dirty="0">
                <a:ea typeface="맑은 고딕" panose="020B0503020000020004" pitchFamily="50" charset="-127"/>
              </a:rPr>
              <a:t>RAW264.7 cells treated with </a:t>
            </a:r>
            <a:r>
              <a:rPr lang="el-GR" altLang="ko-KR" dirty="0">
                <a:ea typeface="맑은 고딕" panose="020B0503020000020004" pitchFamily="50" charset="-127"/>
              </a:rPr>
              <a:t>β</a:t>
            </a:r>
            <a:r>
              <a:rPr lang="en-US" altLang="ko-KR" dirty="0">
                <a:ea typeface="맑은 고딕" panose="020B0503020000020004" pitchFamily="50" charset="-127"/>
              </a:rPr>
              <a:t>-1,3-glucan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66633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7608835" y="841003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그룹 38"/>
          <p:cNvGrpSpPr/>
          <p:nvPr/>
        </p:nvGrpSpPr>
        <p:grpSpPr>
          <a:xfrm>
            <a:off x="6077078" y="1394594"/>
            <a:ext cx="3738130" cy="4114920"/>
            <a:chOff x="6077078" y="1394594"/>
            <a:chExt cx="3738130" cy="4114920"/>
          </a:xfrm>
        </p:grpSpPr>
        <p:grpSp>
          <p:nvGrpSpPr>
            <p:cNvPr id="27" name="그룹 26"/>
            <p:cNvGrpSpPr/>
            <p:nvPr/>
          </p:nvGrpSpPr>
          <p:grpSpPr>
            <a:xfrm>
              <a:off x="6976221" y="1394594"/>
              <a:ext cx="2838987" cy="4114920"/>
              <a:chOff x="6830308" y="1266397"/>
              <a:chExt cx="2494354" cy="3920387"/>
            </a:xfrm>
          </p:grpSpPr>
          <p:pic>
            <p:nvPicPr>
              <p:cNvPr id="19" name="그림 18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5110"/>
                        </a14:imgEffect>
                        <a14:imgEffect>
                          <a14:saturation sat="69000"/>
                        </a14:imgEffect>
                        <a14:imgEffect>
                          <a14:brightnessContrast bright="57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879" t="33202" r="29309" b="7450"/>
              <a:stretch/>
            </p:blipFill>
            <p:spPr>
              <a:xfrm>
                <a:off x="8813260" y="1266397"/>
                <a:ext cx="511402" cy="3920387"/>
              </a:xfrm>
              <a:prstGeom prst="rect">
                <a:avLst/>
              </a:prstGeom>
            </p:spPr>
          </p:pic>
          <p:pic>
            <p:nvPicPr>
              <p:cNvPr id="26" name="그림 25"/>
              <p:cNvPicPr>
                <a:picLocks noChangeAspect="1"/>
              </p:cNvPicPr>
              <p:nvPr/>
            </p:nvPicPr>
            <p:blipFill rotWithShape="1">
              <a:blip r:embed="rId4"/>
              <a:srcRect r="1563"/>
              <a:stretch/>
            </p:blipFill>
            <p:spPr>
              <a:xfrm>
                <a:off x="6830308" y="1328473"/>
                <a:ext cx="1982953" cy="3858311"/>
              </a:xfrm>
              <a:prstGeom prst="rect">
                <a:avLst/>
              </a:prstGeom>
            </p:spPr>
          </p:pic>
        </p:grpSp>
        <p:sp>
          <p:nvSpPr>
            <p:cNvPr id="29" name="TextBox 28"/>
            <p:cNvSpPr txBox="1"/>
            <p:nvPr/>
          </p:nvSpPr>
          <p:spPr>
            <a:xfrm>
              <a:off x="6282262" y="1556603"/>
              <a:ext cx="5180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288674" y="2232675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116351" y="2805799"/>
              <a:ext cx="849912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RG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1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077078" y="3586700"/>
              <a:ext cx="928459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10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77078" y="4205655"/>
              <a:ext cx="928459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30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077078" y="4931367"/>
              <a:ext cx="928459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60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2589679" y="841003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Thymus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그룹 37"/>
          <p:cNvGrpSpPr/>
          <p:nvPr/>
        </p:nvGrpSpPr>
        <p:grpSpPr>
          <a:xfrm>
            <a:off x="1025399" y="1413410"/>
            <a:ext cx="3849398" cy="4114920"/>
            <a:chOff x="1025399" y="1413410"/>
            <a:chExt cx="3849398" cy="4114920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244" t="25277" r="35183" b="33996"/>
            <a:stretch/>
          </p:blipFill>
          <p:spPr>
            <a:xfrm>
              <a:off x="1932454" y="1415141"/>
              <a:ext cx="2376899" cy="39624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230583" y="1624690"/>
              <a:ext cx="5180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NC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228032" y="2271578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64672" y="2805790"/>
              <a:ext cx="849912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RG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1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25399" y="3489418"/>
              <a:ext cx="928459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10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25399" y="4118096"/>
              <a:ext cx="928459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30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25399" y="4785445"/>
              <a:ext cx="928459" cy="5386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</a:t>
              </a:r>
              <a:b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600mg/kg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그림 35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  <a14:imgEffect>
                        <a14:colorTemperature colorTemp="5110"/>
                      </a14:imgEffect>
                      <a14:imgEffect>
                        <a14:saturation sat="69000"/>
                      </a14:imgEffect>
                      <a14:imgEffect>
                        <a14:brightnessContrast bright="58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79" t="33202" r="29309" b="7450"/>
            <a:stretch/>
          </p:blipFill>
          <p:spPr>
            <a:xfrm>
              <a:off x="4292737" y="1413410"/>
              <a:ext cx="582060" cy="4114920"/>
            </a:xfrm>
            <a:prstGeom prst="rect">
              <a:avLst/>
            </a:prstGeom>
          </p:spPr>
        </p:pic>
      </p:grpSp>
      <p:sp>
        <p:nvSpPr>
          <p:cNvPr id="2" name="TextBox 1"/>
          <p:cNvSpPr txBox="1"/>
          <p:nvPr/>
        </p:nvSpPr>
        <p:spPr>
          <a:xfrm>
            <a:off x="651164" y="6026727"/>
            <a:ext cx="916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/>
              <a:t>Supplementary Figure S3</a:t>
            </a:r>
            <a:r>
              <a:rPr lang="en-US" altLang="ko-KR" dirty="0"/>
              <a:t>. Changes of in the spleen and thymus of EP-treated mice.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58310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5</Words>
  <Application>Microsoft Office PowerPoint</Application>
  <PresentationFormat>Widescreen</PresentationFormat>
  <Paragraphs>28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Office 테마</vt:lpstr>
      <vt:lpstr>Prism 5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환희</dc:creator>
  <cp:lastModifiedBy>MDPI</cp:lastModifiedBy>
  <cp:revision>4</cp:revision>
  <dcterms:created xsi:type="dcterms:W3CDTF">2024-08-16T01:06:20Z</dcterms:created>
  <dcterms:modified xsi:type="dcterms:W3CDTF">2024-09-18T15:52:52Z</dcterms:modified>
</cp:coreProperties>
</file>